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7321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lderisi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3) Diabetologia DOI 10.1007/s00125-021-06011-5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The disposition index results from the hyperbolic interaction of insulin secretion (beta cell responsiveness) and insulin sensitivity</a:t>
            </a:r>
            <a:endParaRPr lang="en-GB" sz="1800" b="1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876993E-4690-B125-FC79-443EC012825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7744" y="884531"/>
            <a:ext cx="4567326" cy="4848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05264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Galderisi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3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1-06011-5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Glucose and C-peptide profiles during an OGTT through progression from healthy beta cells (a) to stage 1 (b), stage 2 (c) and stage 3 (d) type 1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D2EA742-A771-7568-76B7-CF721E4A48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1031" y="1196752"/>
            <a:ext cx="7041938" cy="472925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On-screen Show (4:3)</PresentationFormat>
  <Paragraphs>1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7</cp:revision>
  <dcterms:created xsi:type="dcterms:W3CDTF">2016-06-15T12:53:43Z</dcterms:created>
  <dcterms:modified xsi:type="dcterms:W3CDTF">2024-11-07T15:48:53Z</dcterms:modified>
</cp:coreProperties>
</file>